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C4608"/>
    <a:srgbClr val="215948"/>
    <a:srgbClr val="1D4E89"/>
    <a:srgbClr val="F4640C"/>
    <a:srgbClr val="38987A"/>
    <a:srgbClr val="286CBE"/>
    <a:srgbClr val="FABB94"/>
    <a:srgbClr val="A9DFCE"/>
    <a:srgbClr val="B6D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61" autoAdjust="0"/>
    <p:restoredTop sz="94660"/>
  </p:normalViewPr>
  <p:slideViewPr>
    <p:cSldViewPr snapToGrid="0">
      <p:cViewPr varScale="1">
        <p:scale>
          <a:sx n="70" d="100"/>
          <a:sy n="70" d="100"/>
        </p:scale>
        <p:origin x="90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river10\Documents\carcharodonta%20paper\figure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92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Expression levels of genes without significant sex/stage differences</a:t>
            </a:r>
          </a:p>
        </c:rich>
      </c:tx>
      <c:layout>
        <c:manualLayout>
          <c:xMode val="edge"/>
          <c:yMode val="edge"/>
          <c:x val="0.23165908106975461"/>
          <c:y val="6.509997886031858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92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9</c:f>
              <c:strCache>
                <c:ptCount val="1"/>
                <c:pt idx="0">
                  <c:v>IV</c:v>
                </c:pt>
              </c:strCache>
            </c:strRef>
          </c:tx>
          <c:spPr>
            <a:solidFill>
              <a:srgbClr val="B6D0F0"/>
            </a:solidFill>
            <a:ln>
              <a:solidFill>
                <a:schemeClr val="accent1"/>
              </a:solidFill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rgbClr val="A9DFCE"/>
              </a:solidFill>
              <a:ln>
                <a:solidFill>
                  <a:srgbClr val="38987A"/>
                </a:solidFill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A9DFCE"/>
              </a:solidFill>
              <a:ln>
                <a:solidFill>
                  <a:srgbClr val="38987A"/>
                </a:solidFill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A9DFCE"/>
              </a:solidFill>
              <a:ln>
                <a:solidFill>
                  <a:srgbClr val="38987A"/>
                </a:solidFill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A9DFCE"/>
              </a:solidFill>
              <a:ln>
                <a:solidFill>
                  <a:srgbClr val="38987A"/>
                </a:solidFill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rgbClr val="FABB94"/>
              </a:solidFill>
              <a:ln>
                <a:solidFill>
                  <a:srgbClr val="F4640C"/>
                </a:solidFill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rgbClr val="FABB94"/>
              </a:solidFill>
              <a:ln>
                <a:solidFill>
                  <a:srgbClr val="F4640C"/>
                </a:solidFill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B$25:$K$25</c:f>
                <c:numCache>
                  <c:formatCode>General</c:formatCode>
                  <c:ptCount val="10"/>
                  <c:pt idx="0">
                    <c:v>2.8231557803930534E-6</c:v>
                  </c:pt>
                  <c:pt idx="1">
                    <c:v>1.2931420842275431E-6</c:v>
                  </c:pt>
                  <c:pt idx="2">
                    <c:v>6.7043795469589824E-7</c:v>
                  </c:pt>
                  <c:pt idx="3">
                    <c:v>2.4227472337316814E-7</c:v>
                  </c:pt>
                  <c:pt idx="4">
                    <c:v>1.7095404887878429E-6</c:v>
                  </c:pt>
                  <c:pt idx="5">
                    <c:v>2.2632343280062315E-7</c:v>
                  </c:pt>
                  <c:pt idx="6">
                    <c:v>3.2815703804517682E-6</c:v>
                  </c:pt>
                  <c:pt idx="7">
                    <c:v>1.3752470847037268E-4</c:v>
                  </c:pt>
                  <c:pt idx="8">
                    <c:v>3.9109223558424556E-6</c:v>
                  </c:pt>
                  <c:pt idx="9">
                    <c:v>7.8398279441981342E-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17:$K$18</c:f>
              <c:multiLvlStrCache>
                <c:ptCount val="10"/>
                <c:lvl>
                  <c:pt idx="0">
                    <c:v>M</c:v>
                  </c:pt>
                  <c:pt idx="1">
                    <c:v>F</c:v>
                  </c:pt>
                  <c:pt idx="2">
                    <c:v>M</c:v>
                  </c:pt>
                  <c:pt idx="3">
                    <c:v>F</c:v>
                  </c:pt>
                  <c:pt idx="4">
                    <c:v>M</c:v>
                  </c:pt>
                  <c:pt idx="5">
                    <c:v>F</c:v>
                  </c:pt>
                  <c:pt idx="6">
                    <c:v>M</c:v>
                  </c:pt>
                  <c:pt idx="7">
                    <c:v>F</c:v>
                  </c:pt>
                  <c:pt idx="8">
                    <c:v>M</c:v>
                  </c:pt>
                  <c:pt idx="9">
                    <c:v>F</c:v>
                  </c:pt>
                </c:lvl>
                <c:lvl>
                  <c:pt idx="0">
                    <c:v>Pax6</c:v>
                  </c:pt>
                  <c:pt idx="2">
                    <c:v>SO17</c:v>
                  </c:pt>
                  <c:pt idx="4">
                    <c:v>Da</c:v>
                  </c:pt>
                  <c:pt idx="6">
                    <c:v>Elav</c:v>
                  </c:pt>
                  <c:pt idx="8">
                    <c:v>PKC</c:v>
                  </c:pt>
                </c:lvl>
              </c:multiLvlStrCache>
            </c:multiLvlStrRef>
          </c:cat>
          <c:val>
            <c:numRef>
              <c:f>Sheet1!$B$19:$K$19</c:f>
              <c:numCache>
                <c:formatCode>General</c:formatCode>
                <c:ptCount val="10"/>
                <c:pt idx="0">
                  <c:v>4.1932356243497894E-6</c:v>
                </c:pt>
                <c:pt idx="1">
                  <c:v>3.6756252266637984E-6</c:v>
                </c:pt>
                <c:pt idx="2">
                  <c:v>9.4194232193668782E-7</c:v>
                </c:pt>
                <c:pt idx="3">
                  <c:v>9.6836981996849939E-7</c:v>
                </c:pt>
                <c:pt idx="4">
                  <c:v>1.8722199050512287E-6</c:v>
                </c:pt>
                <c:pt idx="5">
                  <c:v>6.4517038645129494E-7</c:v>
                </c:pt>
                <c:pt idx="6">
                  <c:v>9.9241750671395538E-6</c:v>
                </c:pt>
                <c:pt idx="7">
                  <c:v>1.5368175386037153E-4</c:v>
                </c:pt>
                <c:pt idx="8">
                  <c:v>1.0000022977743951E-5</c:v>
                </c:pt>
                <c:pt idx="9">
                  <c:v>2.3157981511675675E-5</c:v>
                </c:pt>
              </c:numCache>
            </c:numRef>
          </c:val>
        </c:ser>
        <c:ser>
          <c:idx val="1"/>
          <c:order val="1"/>
          <c:tx>
            <c:strRef>
              <c:f>Sheet1!$A$20</c:f>
              <c:strCache>
                <c:ptCount val="1"/>
                <c:pt idx="0">
                  <c:v>V</c:v>
                </c:pt>
              </c:strCache>
            </c:strRef>
          </c:tx>
          <c:spPr>
            <a:solidFill>
              <a:srgbClr val="286CBE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286CBE"/>
              </a:solidFill>
              <a:ln>
                <a:noFill/>
              </a:ln>
              <a:effectLst/>
            </c:spPr>
          </c:dPt>
          <c:dPt>
            <c:idx val="4"/>
            <c:invertIfNegative val="0"/>
            <c:bubble3D val="0"/>
            <c:spPr>
              <a:solidFill>
                <a:srgbClr val="38987A"/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38987A"/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38987A"/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38987A"/>
              </a:solidFill>
              <a:ln>
                <a:noFill/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rgbClr val="F4640C"/>
              </a:solidFill>
              <a:ln>
                <a:noFill/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rgbClr val="F4640C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B$26:$K$26</c:f>
                <c:numCache>
                  <c:formatCode>General</c:formatCode>
                  <c:ptCount val="10"/>
                  <c:pt idx="0">
                    <c:v>1.4840836559416567E-6</c:v>
                  </c:pt>
                  <c:pt idx="1">
                    <c:v>2.3752134253465568E-6</c:v>
                  </c:pt>
                  <c:pt idx="2">
                    <c:v>1.5263404488727773E-6</c:v>
                  </c:pt>
                  <c:pt idx="3">
                    <c:v>1.2081619915194525E-6</c:v>
                  </c:pt>
                  <c:pt idx="4">
                    <c:v>6.9595507887824694E-7</c:v>
                  </c:pt>
                  <c:pt idx="5">
                    <c:v>3.5649188091292589E-7</c:v>
                  </c:pt>
                  <c:pt idx="6">
                    <c:v>6.7511912975106871E-6</c:v>
                  </c:pt>
                  <c:pt idx="7">
                    <c:v>1.7108782463410846E-6</c:v>
                  </c:pt>
                  <c:pt idx="8">
                    <c:v>2.8047797910214988E-6</c:v>
                  </c:pt>
                  <c:pt idx="9">
                    <c:v>1.1828919100566916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17:$K$18</c:f>
              <c:multiLvlStrCache>
                <c:ptCount val="10"/>
                <c:lvl>
                  <c:pt idx="0">
                    <c:v>M</c:v>
                  </c:pt>
                  <c:pt idx="1">
                    <c:v>F</c:v>
                  </c:pt>
                  <c:pt idx="2">
                    <c:v>M</c:v>
                  </c:pt>
                  <c:pt idx="3">
                    <c:v>F</c:v>
                  </c:pt>
                  <c:pt idx="4">
                    <c:v>M</c:v>
                  </c:pt>
                  <c:pt idx="5">
                    <c:v>F</c:v>
                  </c:pt>
                  <c:pt idx="6">
                    <c:v>M</c:v>
                  </c:pt>
                  <c:pt idx="7">
                    <c:v>F</c:v>
                  </c:pt>
                  <c:pt idx="8">
                    <c:v>M</c:v>
                  </c:pt>
                  <c:pt idx="9">
                    <c:v>F</c:v>
                  </c:pt>
                </c:lvl>
                <c:lvl>
                  <c:pt idx="0">
                    <c:v>Pax6</c:v>
                  </c:pt>
                  <c:pt idx="2">
                    <c:v>SO17</c:v>
                  </c:pt>
                  <c:pt idx="4">
                    <c:v>Da</c:v>
                  </c:pt>
                  <c:pt idx="6">
                    <c:v>Elav</c:v>
                  </c:pt>
                  <c:pt idx="8">
                    <c:v>PKC</c:v>
                  </c:pt>
                </c:lvl>
              </c:multiLvlStrCache>
            </c:multiLvlStrRef>
          </c:cat>
          <c:val>
            <c:numRef>
              <c:f>Sheet1!$B$20:$K$20</c:f>
              <c:numCache>
                <c:formatCode>General</c:formatCode>
                <c:ptCount val="10"/>
                <c:pt idx="0">
                  <c:v>2.8665622613009165E-6</c:v>
                </c:pt>
                <c:pt idx="1">
                  <c:v>4.3169824528109424E-6</c:v>
                </c:pt>
                <c:pt idx="2">
                  <c:v>4.5852657083819438E-6</c:v>
                </c:pt>
                <c:pt idx="3">
                  <c:v>4.4599049501347602E-6</c:v>
                </c:pt>
                <c:pt idx="4">
                  <c:v>1.0997301331173898E-6</c:v>
                </c:pt>
                <c:pt idx="5">
                  <c:v>8.5126196204478156E-7</c:v>
                </c:pt>
                <c:pt idx="6">
                  <c:v>1.4395075554473995E-5</c:v>
                </c:pt>
                <c:pt idx="7">
                  <c:v>6.2343027107741471E-6</c:v>
                </c:pt>
                <c:pt idx="8">
                  <c:v>5.5891217665504765E-6</c:v>
                </c:pt>
                <c:pt idx="9">
                  <c:v>1.6388808105825667E-3</c:v>
                </c:pt>
              </c:numCache>
            </c:numRef>
          </c:val>
        </c:ser>
        <c:ser>
          <c:idx val="2"/>
          <c:order val="2"/>
          <c:tx>
            <c:strRef>
              <c:f>Sheet1!$A$21</c:f>
              <c:strCache>
                <c:ptCount val="1"/>
                <c:pt idx="0">
                  <c:v>Adult</c:v>
                </c:pt>
              </c:strCache>
            </c:strRef>
          </c:tx>
          <c:spPr>
            <a:solidFill>
              <a:srgbClr val="1D4E89"/>
            </a:solidFill>
            <a:ln>
              <a:noFill/>
            </a:ln>
            <a:effectLst/>
          </c:spPr>
          <c:invertIfNegative val="0"/>
          <c:dPt>
            <c:idx val="4"/>
            <c:invertIfNegative val="0"/>
            <c:bubble3D val="0"/>
            <c:spPr>
              <a:solidFill>
                <a:srgbClr val="215948"/>
              </a:solidFill>
              <a:ln>
                <a:noFill/>
              </a:ln>
              <a:effectLst/>
            </c:spPr>
          </c:dPt>
          <c:dPt>
            <c:idx val="5"/>
            <c:invertIfNegative val="0"/>
            <c:bubble3D val="0"/>
            <c:spPr>
              <a:solidFill>
                <a:srgbClr val="215948"/>
              </a:solidFill>
              <a:ln>
                <a:noFill/>
              </a:ln>
              <a:effectLst/>
            </c:spPr>
          </c:dPt>
          <c:dPt>
            <c:idx val="6"/>
            <c:invertIfNegative val="0"/>
            <c:bubble3D val="0"/>
            <c:spPr>
              <a:solidFill>
                <a:srgbClr val="215948"/>
              </a:solidFill>
              <a:ln>
                <a:noFill/>
              </a:ln>
              <a:effectLst/>
            </c:spPr>
          </c:dPt>
          <c:dPt>
            <c:idx val="7"/>
            <c:invertIfNegative val="0"/>
            <c:bubble3D val="0"/>
            <c:spPr>
              <a:solidFill>
                <a:srgbClr val="215948"/>
              </a:solidFill>
              <a:ln>
                <a:noFill/>
              </a:ln>
              <a:effectLst/>
            </c:spPr>
          </c:dPt>
          <c:dPt>
            <c:idx val="8"/>
            <c:invertIfNegative val="0"/>
            <c:bubble3D val="0"/>
            <c:spPr>
              <a:solidFill>
                <a:srgbClr val="AC4608"/>
              </a:solidFill>
              <a:ln>
                <a:noFill/>
              </a:ln>
              <a:effectLst/>
            </c:spPr>
          </c:dPt>
          <c:dPt>
            <c:idx val="9"/>
            <c:invertIfNegative val="0"/>
            <c:bubble3D val="0"/>
            <c:spPr>
              <a:solidFill>
                <a:srgbClr val="AC4608"/>
              </a:solidFill>
              <a:ln>
                <a:noFill/>
              </a:ln>
              <a:effectLst/>
            </c:spPr>
          </c:dPt>
          <c:errBars>
            <c:errBarType val="both"/>
            <c:errValType val="cust"/>
            <c:noEndCap val="0"/>
            <c:plus>
              <c:numRef>
                <c:f>Sheet1!$B$27:$K$27</c:f>
                <c:numCache>
                  <c:formatCode>General</c:formatCode>
                  <c:ptCount val="10"/>
                  <c:pt idx="0">
                    <c:v>5.3662239143140548E-5</c:v>
                  </c:pt>
                  <c:pt idx="1">
                    <c:v>6.8212258481986934E-6</c:v>
                  </c:pt>
                  <c:pt idx="2">
                    <c:v>3.1526542082166569E-7</c:v>
                  </c:pt>
                  <c:pt idx="3">
                    <c:v>1.2581550753034299E-6</c:v>
                  </c:pt>
                  <c:pt idx="4">
                    <c:v>1.1397159518682048E-6</c:v>
                  </c:pt>
                  <c:pt idx="5">
                    <c:v>2.3330786698948829E-6</c:v>
                  </c:pt>
                  <c:pt idx="6">
                    <c:v>1.7108782463410846E-6</c:v>
                  </c:pt>
                  <c:pt idx="7">
                    <c:v>3.6759833514416149E-6</c:v>
                  </c:pt>
                  <c:pt idx="8">
                    <c:v>4.1905629475817597E-3</c:v>
                  </c:pt>
                  <c:pt idx="9">
                    <c:v>8.7215285264806007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17:$K$18</c:f>
              <c:multiLvlStrCache>
                <c:ptCount val="10"/>
                <c:lvl>
                  <c:pt idx="0">
                    <c:v>M</c:v>
                  </c:pt>
                  <c:pt idx="1">
                    <c:v>F</c:v>
                  </c:pt>
                  <c:pt idx="2">
                    <c:v>M</c:v>
                  </c:pt>
                  <c:pt idx="3">
                    <c:v>F</c:v>
                  </c:pt>
                  <c:pt idx="4">
                    <c:v>M</c:v>
                  </c:pt>
                  <c:pt idx="5">
                    <c:v>F</c:v>
                  </c:pt>
                  <c:pt idx="6">
                    <c:v>M</c:v>
                  </c:pt>
                  <c:pt idx="7">
                    <c:v>F</c:v>
                  </c:pt>
                  <c:pt idx="8">
                    <c:v>M</c:v>
                  </c:pt>
                  <c:pt idx="9">
                    <c:v>F</c:v>
                  </c:pt>
                </c:lvl>
                <c:lvl>
                  <c:pt idx="0">
                    <c:v>Pax6</c:v>
                  </c:pt>
                  <c:pt idx="2">
                    <c:v>SO17</c:v>
                  </c:pt>
                  <c:pt idx="4">
                    <c:v>Da</c:v>
                  </c:pt>
                  <c:pt idx="6">
                    <c:v>Elav</c:v>
                  </c:pt>
                  <c:pt idx="8">
                    <c:v>PKC</c:v>
                  </c:pt>
                </c:lvl>
              </c:multiLvlStrCache>
            </c:multiLvlStrRef>
          </c:cat>
          <c:val>
            <c:numRef>
              <c:f>Sheet1!$B$21:$K$21</c:f>
              <c:numCache>
                <c:formatCode>General</c:formatCode>
                <c:ptCount val="10"/>
                <c:pt idx="0">
                  <c:v>7.7484039828499269E-5</c:v>
                </c:pt>
                <c:pt idx="1">
                  <c:v>1.4239566271635742E-5</c:v>
                </c:pt>
                <c:pt idx="2">
                  <c:v>1.1070235957415448E-6</c:v>
                </c:pt>
                <c:pt idx="3">
                  <c:v>4.5421819080886322E-6</c:v>
                </c:pt>
                <c:pt idx="4">
                  <c:v>2.6164687805797056E-6</c:v>
                </c:pt>
                <c:pt idx="5">
                  <c:v>4.5075705651299405E-6</c:v>
                </c:pt>
                <c:pt idx="6">
                  <c:v>1.1578323692339517E-5</c:v>
                </c:pt>
                <c:pt idx="7">
                  <c:v>6.869911316525545E-6</c:v>
                </c:pt>
                <c:pt idx="8">
                  <c:v>8.2554066615837564E-3</c:v>
                </c:pt>
                <c:pt idx="9">
                  <c:v>1.4161681255133141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262432"/>
        <c:axId val="211262824"/>
      </c:barChart>
      <c:catAx>
        <c:axId val="211262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262824"/>
        <c:crossesAt val="0"/>
        <c:auto val="0"/>
        <c:lblAlgn val="ctr"/>
        <c:lblOffset val="100"/>
        <c:noMultiLvlLbl val="0"/>
      </c:catAx>
      <c:valAx>
        <c:axId val="211262824"/>
        <c:scaling>
          <c:logBase val="10"/>
          <c:orientation val="minMax"/>
          <c:max val="5.000000000000001E-2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ng/90ng total RNA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112624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0549</cdr:x>
      <cdr:y>0.34143</cdr:y>
    </cdr:from>
    <cdr:to>
      <cdr:x>0.55769</cdr:x>
      <cdr:y>0.45275</cdr:y>
    </cdr:to>
    <cdr:grpSp>
      <cdr:nvGrpSpPr>
        <cdr:cNvPr id="11" name="Group 10"/>
        <cdr:cNvGrpSpPr/>
      </cdr:nvGrpSpPr>
      <cdr:grpSpPr>
        <a:xfrm xmlns:a="http://schemas.openxmlformats.org/drawingml/2006/main">
          <a:off x="5022377" y="1966438"/>
          <a:ext cx="518614" cy="641128"/>
          <a:chOff x="2149874" y="4604692"/>
          <a:chExt cx="440574" cy="582888"/>
        </a:xfrm>
      </cdr:grpSpPr>
      <cdr:sp macro="" textlink="">
        <cdr:nvSpPr>
          <cdr:cNvPr id="13" name="Rectangle 12"/>
          <cdr:cNvSpPr/>
        </cdr:nvSpPr>
        <cdr:spPr>
          <a:xfrm xmlns:a="http://schemas.openxmlformats.org/drawingml/2006/main">
            <a:off x="2480685" y="4604692"/>
            <a:ext cx="109763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FABB94"/>
          </a:solidFill>
          <a:ln xmlns:a="http://schemas.openxmlformats.org/drawingml/2006/main">
            <a:solidFill>
              <a:srgbClr val="F4640C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4" name="Rectangle 13"/>
          <cdr:cNvSpPr/>
        </cdr:nvSpPr>
        <cdr:spPr>
          <a:xfrm xmlns:a="http://schemas.openxmlformats.org/drawingml/2006/main">
            <a:off x="2315235" y="4604692"/>
            <a:ext cx="109763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A9DFCE"/>
          </a:solidFill>
          <a:ln xmlns:a="http://schemas.openxmlformats.org/drawingml/2006/main">
            <a:solidFill>
              <a:srgbClr val="38987A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5" name="Rectangle 14"/>
          <cdr:cNvSpPr/>
        </cdr:nvSpPr>
        <cdr:spPr>
          <a:xfrm xmlns:a="http://schemas.openxmlformats.org/drawingml/2006/main">
            <a:off x="2149874" y="4604692"/>
            <a:ext cx="109674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B6D0F0"/>
          </a:solidFill>
          <a:ln xmlns:a="http://schemas.openxmlformats.org/drawingml/2006/main">
            <a:solidFill>
              <a:srgbClr val="286CBE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6" name="Rectangle 15"/>
          <cdr:cNvSpPr/>
        </cdr:nvSpPr>
        <cdr:spPr>
          <a:xfrm xmlns:a="http://schemas.openxmlformats.org/drawingml/2006/main">
            <a:off x="2480685" y="4841270"/>
            <a:ext cx="109763" cy="109732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F4640C"/>
          </a:solidFill>
          <a:ln xmlns:a="http://schemas.openxmlformats.org/drawingml/2006/main">
            <a:solidFill>
              <a:srgbClr val="F4640C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7" name="Rectangle 16"/>
          <cdr:cNvSpPr/>
        </cdr:nvSpPr>
        <cdr:spPr>
          <a:xfrm xmlns:a="http://schemas.openxmlformats.org/drawingml/2006/main">
            <a:off x="2315235" y="4841270"/>
            <a:ext cx="109763" cy="109732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38987A"/>
          </a:solidFill>
          <a:ln xmlns:a="http://schemas.openxmlformats.org/drawingml/2006/main">
            <a:solidFill>
              <a:srgbClr val="38987A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8" name="Rectangle 17"/>
          <cdr:cNvSpPr/>
        </cdr:nvSpPr>
        <cdr:spPr>
          <a:xfrm xmlns:a="http://schemas.openxmlformats.org/drawingml/2006/main">
            <a:off x="2149874" y="4841270"/>
            <a:ext cx="109674" cy="109732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286CBE"/>
          </a:solidFill>
          <a:ln xmlns:a="http://schemas.openxmlformats.org/drawingml/2006/main">
            <a:solidFill>
              <a:srgbClr val="286CBE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19" name="Rectangle 18"/>
          <cdr:cNvSpPr/>
        </cdr:nvSpPr>
        <cdr:spPr>
          <a:xfrm xmlns:a="http://schemas.openxmlformats.org/drawingml/2006/main">
            <a:off x="2480685" y="5077847"/>
            <a:ext cx="109763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AC4608"/>
          </a:solidFill>
          <a:ln xmlns:a="http://schemas.openxmlformats.org/drawingml/2006/main">
            <a:solidFill>
              <a:srgbClr val="AC4608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20" name="Rectangle 19"/>
          <cdr:cNvSpPr/>
        </cdr:nvSpPr>
        <cdr:spPr>
          <a:xfrm xmlns:a="http://schemas.openxmlformats.org/drawingml/2006/main">
            <a:off x="2315235" y="5077847"/>
            <a:ext cx="109763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215948"/>
          </a:solidFill>
          <a:ln xmlns:a="http://schemas.openxmlformats.org/drawingml/2006/main">
            <a:solidFill>
              <a:srgbClr val="215948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  <cdr:sp macro="" textlink="">
        <cdr:nvSpPr>
          <cdr:cNvPr id="21" name="Rectangle 20"/>
          <cdr:cNvSpPr/>
        </cdr:nvSpPr>
        <cdr:spPr>
          <a:xfrm xmlns:a="http://schemas.openxmlformats.org/drawingml/2006/main">
            <a:off x="2149874" y="5077847"/>
            <a:ext cx="109674" cy="109733"/>
          </a:xfrm>
          <a:prstGeom xmlns:a="http://schemas.openxmlformats.org/drawingml/2006/main" prst="rect">
            <a:avLst/>
          </a:prstGeom>
          <a:solidFill xmlns:a="http://schemas.openxmlformats.org/drawingml/2006/main">
            <a:srgbClr val="1D4E89"/>
          </a:solidFill>
          <a:ln xmlns:a="http://schemas.openxmlformats.org/drawingml/2006/main">
            <a:solidFill>
              <a:srgbClr val="1D4E89"/>
            </a:solidFill>
          </a:ln>
        </cdr:spPr>
        <cdr:style>
          <a:lnRef xmlns:a="http://schemas.openxmlformats.org/drawingml/2006/main" idx="2">
            <a:schemeClr val="accent1">
              <a:shade val="50000"/>
            </a:schemeClr>
          </a:lnRef>
          <a:fillRef xmlns:a="http://schemas.openxmlformats.org/drawingml/2006/main" idx="1">
            <a:schemeClr val="accent1"/>
          </a:fillRef>
          <a:effectRef xmlns:a="http://schemas.openxmlformats.org/drawingml/2006/main" idx="0">
            <a:schemeClr val="accent1"/>
          </a:effectRef>
          <a:fontRef xmlns:a="http://schemas.openxmlformats.org/drawingml/2006/main" idx="minor">
            <a:schemeClr val="lt1"/>
          </a:fontRef>
        </cdr:style>
        <cdr:txBody>
          <a:bodyPr xmlns:a="http://schemas.openxmlformats.org/drawingml/2006/main"/>
          <a:lstStyle xmlns:a="http://schemas.openxmlformats.org/drawingml/2006/main"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 xmlns:a="http://schemas.openxmlformats.org/drawingml/2006/main">
            <a:endParaRPr lang="en-US"/>
          </a:p>
        </cdr:txBody>
      </cdr:sp>
    </cdr:grpSp>
  </cdr:relSizeAnchor>
  <cdr:relSizeAnchor xmlns:cdr="http://schemas.openxmlformats.org/drawingml/2006/chartDrawing">
    <cdr:from>
      <cdr:x>0.55403</cdr:x>
      <cdr:y>0.32614</cdr:y>
    </cdr:from>
    <cdr:to>
      <cdr:x>0.62479</cdr:x>
      <cdr:y>0.51524</cdr:y>
    </cdr:to>
    <cdr:sp macro="" textlink="">
      <cdr:nvSpPr>
        <cdr:cNvPr id="12" name="TextBox 16"/>
        <cdr:cNvSpPr txBox="1"/>
      </cdr:nvSpPr>
      <cdr:spPr>
        <a:xfrm xmlns:a="http://schemas.openxmlformats.org/drawingml/2006/main">
          <a:off x="5504632" y="1878365"/>
          <a:ext cx="703038" cy="108907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600" dirty="0" smtClean="0"/>
            <a:t>IV</a:t>
          </a:r>
        </a:p>
        <a:p xmlns:a="http://schemas.openxmlformats.org/drawingml/2006/main">
          <a:r>
            <a:rPr lang="en-US" sz="1600" dirty="0" smtClean="0"/>
            <a:t>V</a:t>
          </a:r>
        </a:p>
        <a:p xmlns:a="http://schemas.openxmlformats.org/drawingml/2006/main">
          <a:r>
            <a:rPr lang="en-US" sz="1600" dirty="0" smtClean="0"/>
            <a:t>Adult</a:t>
          </a:r>
          <a:endParaRPr lang="en-US" sz="1600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80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9565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07778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79519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768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4277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4882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6120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278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0986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9398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E9E29-0DC4-436E-B7CE-445D65180843}" type="datetimeFigureOut">
              <a:rPr lang="en-US" smtClean="0"/>
              <a:t>6/10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393FAC-75F4-4C39-8282-71E7CDF9A8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3195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7159501"/>
              </p:ext>
            </p:extLst>
          </p:nvPr>
        </p:nvGraphicFramePr>
        <p:xfrm>
          <a:off x="545910" y="777922"/>
          <a:ext cx="9935571" cy="57593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4776717" y="30161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8846024" y="209038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0869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16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the Pacifi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jna Rivera</dc:creator>
  <cp:lastModifiedBy>Ajna Rivera</cp:lastModifiedBy>
  <cp:revision>6</cp:revision>
  <dcterms:created xsi:type="dcterms:W3CDTF">2015-06-09T17:22:55Z</dcterms:created>
  <dcterms:modified xsi:type="dcterms:W3CDTF">2015-06-10T17:52:15Z</dcterms:modified>
</cp:coreProperties>
</file>